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84" r:id="rId1"/>
  </p:sldMasterIdLst>
  <p:sldIdLst>
    <p:sldId id="258" r:id="rId2"/>
  </p:sldIdLst>
  <p:sldSz cx="25600025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25" d="100"/>
          <a:sy n="25" d="100"/>
        </p:scale>
        <p:origin x="36" y="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00003" y="2356703"/>
            <a:ext cx="19200019" cy="5013407"/>
          </a:xfrm>
        </p:spPr>
        <p:txBody>
          <a:bodyPr anchor="b"/>
          <a:lstStyle>
            <a:lvl1pPr algn="ctr"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200003" y="7563446"/>
            <a:ext cx="19200019" cy="3476717"/>
          </a:xfrm>
        </p:spPr>
        <p:txBody>
          <a:bodyPr/>
          <a:lstStyle>
            <a:lvl1pPr marL="0" indent="0" algn="ctr">
              <a:buNone/>
              <a:defRPr sz="5039"/>
            </a:lvl1pPr>
            <a:lvl2pPr marL="959983" indent="0" algn="ctr">
              <a:buNone/>
              <a:defRPr sz="4199"/>
            </a:lvl2pPr>
            <a:lvl3pPr marL="1919966" indent="0" algn="ctr">
              <a:buNone/>
              <a:defRPr sz="3779"/>
            </a:lvl3pPr>
            <a:lvl4pPr marL="2879949" indent="0" algn="ctr">
              <a:buNone/>
              <a:defRPr sz="3360"/>
            </a:lvl4pPr>
            <a:lvl5pPr marL="3839931" indent="0" algn="ctr">
              <a:buNone/>
              <a:defRPr sz="3360"/>
            </a:lvl5pPr>
            <a:lvl6pPr marL="4799914" indent="0" algn="ctr">
              <a:buNone/>
              <a:defRPr sz="3360"/>
            </a:lvl6pPr>
            <a:lvl7pPr marL="5759897" indent="0" algn="ctr">
              <a:buNone/>
              <a:defRPr sz="3360"/>
            </a:lvl7pPr>
            <a:lvl8pPr marL="6719880" indent="0" algn="ctr">
              <a:buNone/>
              <a:defRPr sz="3360"/>
            </a:lvl8pPr>
            <a:lvl9pPr marL="7679863" indent="0" algn="ctr">
              <a:buNone/>
              <a:defRPr sz="33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5025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5505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320018" y="766678"/>
            <a:ext cx="5520005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60002" y="766678"/>
            <a:ext cx="16240016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9197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749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46668" y="3590055"/>
            <a:ext cx="22080022" cy="5990088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46668" y="9636811"/>
            <a:ext cx="22080022" cy="3150046"/>
          </a:xfrm>
        </p:spPr>
        <p:txBody>
          <a:bodyPr/>
          <a:lstStyle>
            <a:lvl1pPr marL="0" indent="0">
              <a:buNone/>
              <a:defRPr sz="5039">
                <a:solidFill>
                  <a:schemeClr val="tx1">
                    <a:tint val="75000"/>
                  </a:schemeClr>
                </a:solidFill>
              </a:defRPr>
            </a:lvl1pPr>
            <a:lvl2pPr marL="959983" indent="0">
              <a:buNone/>
              <a:defRPr sz="4199">
                <a:solidFill>
                  <a:schemeClr val="tx1">
                    <a:tint val="75000"/>
                  </a:schemeClr>
                </a:solidFill>
              </a:defRPr>
            </a:lvl2pPr>
            <a:lvl3pPr marL="1919966" indent="0">
              <a:buNone/>
              <a:defRPr sz="3779">
                <a:solidFill>
                  <a:schemeClr val="tx1">
                    <a:tint val="75000"/>
                  </a:schemeClr>
                </a:solidFill>
              </a:defRPr>
            </a:lvl3pPr>
            <a:lvl4pPr marL="2879949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4pPr>
            <a:lvl5pPr marL="3839931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5pPr>
            <a:lvl6pPr marL="4799914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6pPr>
            <a:lvl7pPr marL="5759897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7pPr>
            <a:lvl8pPr marL="671988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8pPr>
            <a:lvl9pPr marL="7679863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69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60002" y="3833390"/>
            <a:ext cx="10880011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960012" y="3833390"/>
            <a:ext cx="10880011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122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3336" y="766679"/>
            <a:ext cx="22080022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63337" y="3530053"/>
            <a:ext cx="10830010" cy="1730025"/>
          </a:xfrm>
        </p:spPr>
        <p:txBody>
          <a:bodyPr anchor="b"/>
          <a:lstStyle>
            <a:lvl1pPr marL="0" indent="0">
              <a:buNone/>
              <a:defRPr sz="5039" b="1"/>
            </a:lvl1pPr>
            <a:lvl2pPr marL="959983" indent="0">
              <a:buNone/>
              <a:defRPr sz="4199" b="1"/>
            </a:lvl2pPr>
            <a:lvl3pPr marL="1919966" indent="0">
              <a:buNone/>
              <a:defRPr sz="3779" b="1"/>
            </a:lvl3pPr>
            <a:lvl4pPr marL="2879949" indent="0">
              <a:buNone/>
              <a:defRPr sz="3360" b="1"/>
            </a:lvl4pPr>
            <a:lvl5pPr marL="3839931" indent="0">
              <a:buNone/>
              <a:defRPr sz="3360" b="1"/>
            </a:lvl5pPr>
            <a:lvl6pPr marL="4799914" indent="0">
              <a:buNone/>
              <a:defRPr sz="3360" b="1"/>
            </a:lvl6pPr>
            <a:lvl7pPr marL="5759897" indent="0">
              <a:buNone/>
              <a:defRPr sz="3360" b="1"/>
            </a:lvl7pPr>
            <a:lvl8pPr marL="6719880" indent="0">
              <a:buNone/>
              <a:defRPr sz="3360" b="1"/>
            </a:lvl8pPr>
            <a:lvl9pPr marL="7679863" indent="0">
              <a:buNone/>
              <a:defRPr sz="3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63337" y="5260078"/>
            <a:ext cx="10830010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960013" y="3530053"/>
            <a:ext cx="10883345" cy="1730025"/>
          </a:xfrm>
        </p:spPr>
        <p:txBody>
          <a:bodyPr anchor="b"/>
          <a:lstStyle>
            <a:lvl1pPr marL="0" indent="0">
              <a:buNone/>
              <a:defRPr sz="5039" b="1"/>
            </a:lvl1pPr>
            <a:lvl2pPr marL="959983" indent="0">
              <a:buNone/>
              <a:defRPr sz="4199" b="1"/>
            </a:lvl2pPr>
            <a:lvl3pPr marL="1919966" indent="0">
              <a:buNone/>
              <a:defRPr sz="3779" b="1"/>
            </a:lvl3pPr>
            <a:lvl4pPr marL="2879949" indent="0">
              <a:buNone/>
              <a:defRPr sz="3360" b="1"/>
            </a:lvl4pPr>
            <a:lvl5pPr marL="3839931" indent="0">
              <a:buNone/>
              <a:defRPr sz="3360" b="1"/>
            </a:lvl5pPr>
            <a:lvl6pPr marL="4799914" indent="0">
              <a:buNone/>
              <a:defRPr sz="3360" b="1"/>
            </a:lvl6pPr>
            <a:lvl7pPr marL="5759897" indent="0">
              <a:buNone/>
              <a:defRPr sz="3360" b="1"/>
            </a:lvl7pPr>
            <a:lvl8pPr marL="6719880" indent="0">
              <a:buNone/>
              <a:defRPr sz="3360" b="1"/>
            </a:lvl8pPr>
            <a:lvl9pPr marL="7679863" indent="0">
              <a:buNone/>
              <a:defRPr sz="3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960013" y="5260078"/>
            <a:ext cx="10883345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4540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8128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788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3337" y="960014"/>
            <a:ext cx="8256674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883345" y="2073365"/>
            <a:ext cx="12960013" cy="10233485"/>
          </a:xfrm>
        </p:spPr>
        <p:txBody>
          <a:bodyPr/>
          <a:lstStyle>
            <a:lvl1pPr>
              <a:defRPr sz="6719"/>
            </a:lvl1pPr>
            <a:lvl2pPr>
              <a:defRPr sz="5879"/>
            </a:lvl2pPr>
            <a:lvl3pPr>
              <a:defRPr sz="5039"/>
            </a:lvl3pPr>
            <a:lvl4pPr>
              <a:defRPr sz="4199"/>
            </a:lvl4pPr>
            <a:lvl5pPr>
              <a:defRPr sz="4199"/>
            </a:lvl5pPr>
            <a:lvl6pPr>
              <a:defRPr sz="4199"/>
            </a:lvl6pPr>
            <a:lvl7pPr>
              <a:defRPr sz="4199"/>
            </a:lvl7pPr>
            <a:lvl8pPr>
              <a:defRPr sz="4199"/>
            </a:lvl8pPr>
            <a:lvl9pPr>
              <a:defRPr sz="419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3337" y="4320064"/>
            <a:ext cx="8256674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59983" indent="0">
              <a:buNone/>
              <a:defRPr sz="2940"/>
            </a:lvl2pPr>
            <a:lvl3pPr marL="1919966" indent="0">
              <a:buNone/>
              <a:defRPr sz="2520"/>
            </a:lvl3pPr>
            <a:lvl4pPr marL="2879949" indent="0">
              <a:buNone/>
              <a:defRPr sz="2100"/>
            </a:lvl4pPr>
            <a:lvl5pPr marL="3839931" indent="0">
              <a:buNone/>
              <a:defRPr sz="2100"/>
            </a:lvl5pPr>
            <a:lvl6pPr marL="4799914" indent="0">
              <a:buNone/>
              <a:defRPr sz="2100"/>
            </a:lvl6pPr>
            <a:lvl7pPr marL="5759897" indent="0">
              <a:buNone/>
              <a:defRPr sz="2100"/>
            </a:lvl7pPr>
            <a:lvl8pPr marL="6719880" indent="0">
              <a:buNone/>
              <a:defRPr sz="2100"/>
            </a:lvl8pPr>
            <a:lvl9pPr marL="7679863" indent="0">
              <a:buNone/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7097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3337" y="960014"/>
            <a:ext cx="8256674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883345" y="2073365"/>
            <a:ext cx="12960013" cy="10233485"/>
          </a:xfrm>
        </p:spPr>
        <p:txBody>
          <a:bodyPr anchor="t"/>
          <a:lstStyle>
            <a:lvl1pPr marL="0" indent="0">
              <a:buNone/>
              <a:defRPr sz="6719"/>
            </a:lvl1pPr>
            <a:lvl2pPr marL="959983" indent="0">
              <a:buNone/>
              <a:defRPr sz="5879"/>
            </a:lvl2pPr>
            <a:lvl3pPr marL="1919966" indent="0">
              <a:buNone/>
              <a:defRPr sz="5039"/>
            </a:lvl3pPr>
            <a:lvl4pPr marL="2879949" indent="0">
              <a:buNone/>
              <a:defRPr sz="4199"/>
            </a:lvl4pPr>
            <a:lvl5pPr marL="3839931" indent="0">
              <a:buNone/>
              <a:defRPr sz="4199"/>
            </a:lvl5pPr>
            <a:lvl6pPr marL="4799914" indent="0">
              <a:buNone/>
              <a:defRPr sz="4199"/>
            </a:lvl6pPr>
            <a:lvl7pPr marL="5759897" indent="0">
              <a:buNone/>
              <a:defRPr sz="4199"/>
            </a:lvl7pPr>
            <a:lvl8pPr marL="6719880" indent="0">
              <a:buNone/>
              <a:defRPr sz="4199"/>
            </a:lvl8pPr>
            <a:lvl9pPr marL="7679863" indent="0">
              <a:buNone/>
              <a:defRPr sz="419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3337" y="4320064"/>
            <a:ext cx="8256674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59983" indent="0">
              <a:buNone/>
              <a:defRPr sz="2940"/>
            </a:lvl2pPr>
            <a:lvl3pPr marL="1919966" indent="0">
              <a:buNone/>
              <a:defRPr sz="2520"/>
            </a:lvl3pPr>
            <a:lvl4pPr marL="2879949" indent="0">
              <a:buNone/>
              <a:defRPr sz="2100"/>
            </a:lvl4pPr>
            <a:lvl5pPr marL="3839931" indent="0">
              <a:buNone/>
              <a:defRPr sz="2100"/>
            </a:lvl5pPr>
            <a:lvl6pPr marL="4799914" indent="0">
              <a:buNone/>
              <a:defRPr sz="2100"/>
            </a:lvl6pPr>
            <a:lvl7pPr marL="5759897" indent="0">
              <a:buNone/>
              <a:defRPr sz="2100"/>
            </a:lvl7pPr>
            <a:lvl8pPr marL="6719880" indent="0">
              <a:buNone/>
              <a:defRPr sz="2100"/>
            </a:lvl8pPr>
            <a:lvl9pPr marL="7679863" indent="0">
              <a:buNone/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519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60002" y="766679"/>
            <a:ext cx="2208002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60002" y="3833390"/>
            <a:ext cx="2208002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60002" y="13346865"/>
            <a:ext cx="576000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9CB07-ADFB-461D-84EC-2AAB15241839}" type="datetimeFigureOut">
              <a:rPr lang="zh-CN" altLang="en-US" smtClean="0"/>
              <a:t>2021/10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480009" y="13346865"/>
            <a:ext cx="864000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8080017" y="13346865"/>
            <a:ext cx="576000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F5AE8-2C55-4414-96A9-C5DDD04299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4718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919966" rtl="0" eaLnBrk="1" latinLnBrk="0" hangingPunct="1">
        <a:lnSpc>
          <a:spcPct val="90000"/>
        </a:lnSpc>
        <a:spcBef>
          <a:spcPct val="0"/>
        </a:spcBef>
        <a:buNone/>
        <a:defRPr sz="92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79991" indent="-479991" algn="l" defTabSz="1919966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587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74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5039" kern="1200">
          <a:solidFill>
            <a:schemeClr val="tx1"/>
          </a:solidFill>
          <a:latin typeface="+mn-lt"/>
          <a:ea typeface="+mn-ea"/>
          <a:cs typeface="+mn-cs"/>
        </a:defRPr>
      </a:lvl2pPr>
      <a:lvl3pPr marL="2399957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4199" kern="1200">
          <a:solidFill>
            <a:schemeClr val="tx1"/>
          </a:solidFill>
          <a:latin typeface="+mn-lt"/>
          <a:ea typeface="+mn-ea"/>
          <a:cs typeface="+mn-cs"/>
        </a:defRPr>
      </a:lvl3pPr>
      <a:lvl4pPr marL="3359940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79" kern="1200">
          <a:solidFill>
            <a:schemeClr val="tx1"/>
          </a:solidFill>
          <a:latin typeface="+mn-lt"/>
          <a:ea typeface="+mn-ea"/>
          <a:cs typeface="+mn-cs"/>
        </a:defRPr>
      </a:lvl4pPr>
      <a:lvl5pPr marL="4319923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79" kern="1200">
          <a:solidFill>
            <a:schemeClr val="tx1"/>
          </a:solidFill>
          <a:latin typeface="+mn-lt"/>
          <a:ea typeface="+mn-ea"/>
          <a:cs typeface="+mn-cs"/>
        </a:defRPr>
      </a:lvl5pPr>
      <a:lvl6pPr marL="5279906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79" kern="1200">
          <a:solidFill>
            <a:schemeClr val="tx1"/>
          </a:solidFill>
          <a:latin typeface="+mn-lt"/>
          <a:ea typeface="+mn-ea"/>
          <a:cs typeface="+mn-cs"/>
        </a:defRPr>
      </a:lvl6pPr>
      <a:lvl7pPr marL="6239888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79" kern="1200">
          <a:solidFill>
            <a:schemeClr val="tx1"/>
          </a:solidFill>
          <a:latin typeface="+mn-lt"/>
          <a:ea typeface="+mn-ea"/>
          <a:cs typeface="+mn-cs"/>
        </a:defRPr>
      </a:lvl7pPr>
      <a:lvl8pPr marL="7199871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79" kern="1200">
          <a:solidFill>
            <a:schemeClr val="tx1"/>
          </a:solidFill>
          <a:latin typeface="+mn-lt"/>
          <a:ea typeface="+mn-ea"/>
          <a:cs typeface="+mn-cs"/>
        </a:defRPr>
      </a:lvl8pPr>
      <a:lvl9pPr marL="8159854" indent="-479991" algn="l" defTabSz="191996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1pPr>
      <a:lvl2pPr marL="959983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2pPr>
      <a:lvl3pPr marL="1919966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3pPr>
      <a:lvl4pPr marL="2879949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4pPr>
      <a:lvl5pPr marL="3839931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5pPr>
      <a:lvl6pPr marL="4799914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6pPr>
      <a:lvl7pPr marL="5759897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7pPr>
      <a:lvl8pPr marL="6719880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8pPr>
      <a:lvl9pPr marL="7679863" algn="l" defTabSz="1919966" rtl="0" eaLnBrk="1" latinLnBrk="0" hangingPunct="1">
        <a:defRPr sz="37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F71F1F27-295F-483C-B510-DA7316CB16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0844906"/>
              </p:ext>
            </p:extLst>
          </p:nvPr>
        </p:nvGraphicFramePr>
        <p:xfrm>
          <a:off x="1579418" y="742531"/>
          <a:ext cx="22132636" cy="1292270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070393">
                  <a:extLst>
                    <a:ext uri="{9D8B030D-6E8A-4147-A177-3AD203B41FA5}">
                      <a16:colId xmlns:a16="http://schemas.microsoft.com/office/drawing/2014/main" val="1783123842"/>
                    </a:ext>
                  </a:extLst>
                </a:gridCol>
                <a:gridCol w="6486771">
                  <a:extLst>
                    <a:ext uri="{9D8B030D-6E8A-4147-A177-3AD203B41FA5}">
                      <a16:colId xmlns:a16="http://schemas.microsoft.com/office/drawing/2014/main" val="1194614959"/>
                    </a:ext>
                  </a:extLst>
                </a:gridCol>
                <a:gridCol w="5049981">
                  <a:extLst>
                    <a:ext uri="{9D8B030D-6E8A-4147-A177-3AD203B41FA5}">
                      <a16:colId xmlns:a16="http://schemas.microsoft.com/office/drawing/2014/main" val="2568832091"/>
                    </a:ext>
                  </a:extLst>
                </a:gridCol>
                <a:gridCol w="1911928">
                  <a:extLst>
                    <a:ext uri="{9D8B030D-6E8A-4147-A177-3AD203B41FA5}">
                      <a16:colId xmlns:a16="http://schemas.microsoft.com/office/drawing/2014/main" val="2470352361"/>
                    </a:ext>
                  </a:extLst>
                </a:gridCol>
                <a:gridCol w="4613563">
                  <a:extLst>
                    <a:ext uri="{9D8B030D-6E8A-4147-A177-3AD203B41FA5}">
                      <a16:colId xmlns:a16="http://schemas.microsoft.com/office/drawing/2014/main" val="741108127"/>
                    </a:ext>
                  </a:extLst>
                </a:gridCol>
              </a:tblGrid>
              <a:tr h="18531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>
                          <a:effectLst/>
                        </a:rPr>
                        <a:t>TCM materials(pinyin)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lant name</a:t>
                      </a:r>
                      <a:endParaRPr lang="zh-CN" altLang="en-US" sz="3600" b="1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algn="ctr" defTabSz="1919966" rtl="0" eaLnBrk="1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zh-CN" sz="3600" b="1" i="0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atin name</a:t>
                      </a:r>
                      <a:endParaRPr lang="zh-CN" altLang="en-US" sz="3600" b="1" i="0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>
                          <a:effectLst/>
                        </a:rPr>
                        <a:t>Part used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>
                          <a:effectLst/>
                        </a:rPr>
                        <a:t>Dry weight (g) of daily</a:t>
                      </a:r>
                      <a:endParaRPr lang="zh-CN" sz="3600" dirty="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>
                          <a:effectLst/>
                        </a:rPr>
                        <a:t>dose in clinic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901052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 err="1">
                          <a:effectLst/>
                        </a:rPr>
                        <a:t>Chaihu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pleurum </a:t>
                      </a: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ense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. 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pleuri Radix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radix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10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04825850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>
                          <a:effectLst/>
                        </a:rPr>
                        <a:t>Baishao</a:t>
                      </a:r>
                      <a:endParaRPr lang="zh-CN" sz="3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onia </a:t>
                      </a: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iflora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ll.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oniae Radix Alba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radix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10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3572821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>
                          <a:effectLst/>
                        </a:rPr>
                        <a:t>Zhishi</a:t>
                      </a:r>
                      <a:endParaRPr lang="zh-CN" sz="3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us  aurantium 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. 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rantii Fructus </a:t>
                      </a:r>
                      <a:r>
                        <a:rPr lang="en-US" altLang="zh-CN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aturus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fruit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10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49201381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>
                          <a:effectLst/>
                        </a:rPr>
                        <a:t>Yujin</a:t>
                      </a:r>
                      <a:endParaRPr lang="zh-CN" sz="3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rcuma </a:t>
                      </a: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omatica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sb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rcumae Radix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rhizome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10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6272507"/>
                  </a:ext>
                </a:extLst>
              </a:tr>
              <a:tr h="141808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>
                          <a:effectLst/>
                        </a:rPr>
                        <a:t>Sharen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urfbainia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llosa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ur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) 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ornick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&amp; 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D.Poulsen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mi Fructus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fruit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10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26174696"/>
                  </a:ext>
                </a:extLst>
              </a:tr>
              <a:tr h="12499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>
                          <a:effectLst/>
                        </a:rPr>
                        <a:t>Baizhu</a:t>
                      </a:r>
                      <a:endParaRPr lang="zh-CN" sz="3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actylodes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cephala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idz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actylodis </a:t>
                      </a:r>
                      <a:r>
                        <a:rPr lang="en-US" altLang="zh-CN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cephalae</a:t>
                      </a:r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izoma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rhizome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/>
                        <a:t>15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72463611"/>
                  </a:ext>
                </a:extLst>
              </a:tr>
              <a:tr h="12499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zh-CN" sz="36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uxiang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zh-CN" sz="3600" i="1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ucklandia</a:t>
                      </a:r>
                      <a:r>
                        <a:rPr lang="en-US" altLang="zh-CN" sz="3600" i="1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3600" i="1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stus</a:t>
                      </a:r>
                      <a:r>
                        <a:rPr lang="en-US" altLang="zh-CN" sz="3600" i="1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36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alc</a:t>
                      </a:r>
                      <a:r>
                        <a:rPr lang="en-US" altLang="zh-CN" sz="36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.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sz="3779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ucklandiae Radix</a:t>
                      </a:r>
                      <a:endParaRPr lang="zh-CN" altLang="en-US" sz="3779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/>
                        <a:t>rhizome</a:t>
                      </a:r>
                    </a:p>
                    <a:p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/>
                        <a:t>10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95381574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 err="1">
                          <a:effectLst/>
                        </a:rPr>
                        <a:t>Huanglian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tis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hinensis 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nch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tidis </a:t>
                      </a:r>
                      <a:r>
                        <a:rPr lang="en-US" altLang="zh-CN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izoma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rhizome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6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16234020"/>
                  </a:ext>
                </a:extLst>
              </a:tr>
              <a:tr h="141808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 err="1">
                          <a:effectLst/>
                        </a:rPr>
                        <a:t>Wuzhuyu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tradium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uticarpum</a:t>
                      </a: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Juss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) </a:t>
                      </a:r>
                      <a:r>
                        <a:rPr lang="en-US" sz="3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.G.Hartley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odiae Fructus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fruit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>
                          <a:effectLst/>
                        </a:rPr>
                        <a:t>6</a:t>
                      </a:r>
                      <a:endParaRPr lang="zh-CN" altLang="en-US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99295772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>
                          <a:effectLst/>
                        </a:rPr>
                        <a:t>Gancao</a:t>
                      </a:r>
                      <a:endParaRPr lang="zh-CN" sz="3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yrrhiza glabra </a:t>
                      </a:r>
                      <a:r>
                        <a:rPr lang="en-US" sz="3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.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yrrhizae Radix et </a:t>
                      </a:r>
                      <a:r>
                        <a:rPr lang="en-US" altLang="zh-CN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izoma</a:t>
                      </a:r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rhizome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6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68170456"/>
                  </a:ext>
                </a:extLst>
              </a:tr>
              <a:tr h="68594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>
                          <a:effectLst/>
                        </a:rPr>
                        <a:t>Total</a:t>
                      </a:r>
                      <a:endParaRPr lang="zh-CN" sz="3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3600" dirty="0">
                          <a:effectLst/>
                        </a:rPr>
                        <a:t> </a:t>
                      </a:r>
                      <a:endParaRPr lang="zh-CN" sz="3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 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3600" dirty="0">
                          <a:effectLst/>
                        </a:rPr>
                        <a:t>93</a:t>
                      </a:r>
                      <a:endParaRPr lang="zh-CN" altLang="en-US" dirty="0"/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01332802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57892BF5-520D-4C1C-A816-AE80CB5F9C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9949" y="0"/>
            <a:ext cx="12450844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4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he composition of </a:t>
            </a:r>
            <a:r>
              <a:rPr kumimoji="0" lang="en-US" altLang="zh-CN" sz="4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hugan</a:t>
            </a:r>
            <a:r>
              <a:rPr kumimoji="0" lang="en-US" altLang="zh-CN" sz="4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4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ewei</a:t>
            </a:r>
            <a:r>
              <a:rPr kumimoji="0" lang="en-US" altLang="zh-CN" sz="4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Decoction (SHD)</a:t>
            </a:r>
            <a:endParaRPr kumimoji="0" lang="en-US" altLang="zh-CN" sz="4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9960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</TotalTime>
  <Words>146</Words>
  <Application>Microsoft Office PowerPoint</Application>
  <PresentationFormat>自定义</PresentationFormat>
  <Paragraphs>6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岳 滢滢</dc:creator>
  <cp:lastModifiedBy>岳 滢滢</cp:lastModifiedBy>
  <cp:revision>13</cp:revision>
  <dcterms:created xsi:type="dcterms:W3CDTF">2021-10-27T11:29:15Z</dcterms:created>
  <dcterms:modified xsi:type="dcterms:W3CDTF">2021-10-29T11:37:53Z</dcterms:modified>
</cp:coreProperties>
</file>